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946" y="25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A4DA50-B11F-4124-98F4-0F8CA101E120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251E06-2D7B-4A83-8938-3DE3396861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0408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D251E06-2D7B-4A83-8938-3DE3396861C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8941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D4E81-F7D7-49D1-94F7-90D6CB3F1A0C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74B16-CF69-4666-8FC3-5CDA5BCC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860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D4E81-F7D7-49D1-94F7-90D6CB3F1A0C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74B16-CF69-4666-8FC3-5CDA5BCC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250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D4E81-F7D7-49D1-94F7-90D6CB3F1A0C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74B16-CF69-4666-8FC3-5CDA5BCC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7864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D4E81-F7D7-49D1-94F7-90D6CB3F1A0C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74B16-CF69-4666-8FC3-5CDA5BCC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789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D4E81-F7D7-49D1-94F7-90D6CB3F1A0C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74B16-CF69-4666-8FC3-5CDA5BCC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3965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D4E81-F7D7-49D1-94F7-90D6CB3F1A0C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74B16-CF69-4666-8FC3-5CDA5BCC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182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D4E81-F7D7-49D1-94F7-90D6CB3F1A0C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74B16-CF69-4666-8FC3-5CDA5BCC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747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D4E81-F7D7-49D1-94F7-90D6CB3F1A0C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74B16-CF69-4666-8FC3-5CDA5BCC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7378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D4E81-F7D7-49D1-94F7-90D6CB3F1A0C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74B16-CF69-4666-8FC3-5CDA5BCC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4841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D4E81-F7D7-49D1-94F7-90D6CB3F1A0C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74B16-CF69-4666-8FC3-5CDA5BCC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6635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D4E81-F7D7-49D1-94F7-90D6CB3F1A0C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74B16-CF69-4666-8FC3-5CDA5BCC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403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AD4E81-F7D7-49D1-94F7-90D6CB3F1A0C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F74B16-CF69-4666-8FC3-5CDA5BCC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0690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9.png"/><Relationship Id="rId18" Type="http://schemas.openxmlformats.org/officeDocument/2006/relationships/image" Target="../media/image14.png"/><Relationship Id="rId26" Type="http://schemas.openxmlformats.org/officeDocument/2006/relationships/image" Target="../media/image22.png"/><Relationship Id="rId3" Type="http://schemas.openxmlformats.org/officeDocument/2006/relationships/image" Target="../media/image1.png"/><Relationship Id="rId21" Type="http://schemas.openxmlformats.org/officeDocument/2006/relationships/image" Target="../media/image17.png"/><Relationship Id="rId7" Type="http://schemas.microsoft.com/office/2007/relationships/hdphoto" Target="../media/hdphoto1.wdp"/><Relationship Id="rId12" Type="http://schemas.openxmlformats.org/officeDocument/2006/relationships/image" Target="../media/image8.png"/><Relationship Id="rId17" Type="http://schemas.openxmlformats.org/officeDocument/2006/relationships/image" Target="../media/image13.png"/><Relationship Id="rId25" Type="http://schemas.openxmlformats.org/officeDocument/2006/relationships/image" Target="../media/image21.png"/><Relationship Id="rId33" Type="http://schemas.openxmlformats.org/officeDocument/2006/relationships/image" Target="../media/image29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2.png"/><Relationship Id="rId20" Type="http://schemas.openxmlformats.org/officeDocument/2006/relationships/image" Target="../media/image16.png"/><Relationship Id="rId29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7.png"/><Relationship Id="rId24" Type="http://schemas.openxmlformats.org/officeDocument/2006/relationships/image" Target="../media/image20.png"/><Relationship Id="rId32" Type="http://schemas.openxmlformats.org/officeDocument/2006/relationships/image" Target="../media/image28.png"/><Relationship Id="rId5" Type="http://schemas.openxmlformats.org/officeDocument/2006/relationships/image" Target="../media/image3.png"/><Relationship Id="rId15" Type="http://schemas.openxmlformats.org/officeDocument/2006/relationships/image" Target="../media/image11.png"/><Relationship Id="rId23" Type="http://schemas.openxmlformats.org/officeDocument/2006/relationships/image" Target="../media/image19.png"/><Relationship Id="rId28" Type="http://schemas.openxmlformats.org/officeDocument/2006/relationships/image" Target="../media/image24.png"/><Relationship Id="rId10" Type="http://schemas.microsoft.com/office/2007/relationships/hdphoto" Target="../media/hdphoto2.wdp"/><Relationship Id="rId19" Type="http://schemas.openxmlformats.org/officeDocument/2006/relationships/image" Target="../media/image15.png"/><Relationship Id="rId31" Type="http://schemas.openxmlformats.org/officeDocument/2006/relationships/image" Target="../media/image27.png"/><Relationship Id="rId4" Type="http://schemas.openxmlformats.org/officeDocument/2006/relationships/image" Target="../media/image2.png"/><Relationship Id="rId9" Type="http://schemas.openxmlformats.org/officeDocument/2006/relationships/image" Target="../media/image6.png"/><Relationship Id="rId14" Type="http://schemas.openxmlformats.org/officeDocument/2006/relationships/image" Target="../media/image10.emf"/><Relationship Id="rId22" Type="http://schemas.openxmlformats.org/officeDocument/2006/relationships/image" Target="../media/image18.png"/><Relationship Id="rId27" Type="http://schemas.openxmlformats.org/officeDocument/2006/relationships/image" Target="../media/image23.png"/><Relationship Id="rId30" Type="http://schemas.openxmlformats.org/officeDocument/2006/relationships/image" Target="../media/image26.png"/><Relationship Id="rId8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-386096" y="2463660"/>
            <a:ext cx="1950249" cy="108203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4"/>
          <a:srcRect l="47585" t="40648" r="1" b="7618"/>
          <a:stretch/>
        </p:blipFill>
        <p:spPr>
          <a:xfrm>
            <a:off x="3648548" y="976188"/>
            <a:ext cx="1171860" cy="1131682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4"/>
          <a:srcRect l="49969" r="1577" b="60568"/>
          <a:stretch/>
        </p:blipFill>
        <p:spPr>
          <a:xfrm>
            <a:off x="3523605" y="-196723"/>
            <a:ext cx="1584707" cy="1261809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3789844" y="923702"/>
            <a:ext cx="97494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HL </a:t>
            </a:r>
            <a:r>
              <a:rPr lang="en-US" sz="10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o</a:t>
            </a:r>
            <a:r>
              <a:rPr lang="en-US" sz="11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LOX </a:t>
            </a:r>
            <a:endParaRPr lang="en-US" dirty="0"/>
          </a:p>
        </p:txBody>
      </p:sp>
      <p:sp>
        <p:nvSpPr>
          <p:cNvPr id="20" name="Rectangle 19"/>
          <p:cNvSpPr/>
          <p:nvPr/>
        </p:nvSpPr>
        <p:spPr>
          <a:xfrm>
            <a:off x="3864654" y="1914135"/>
            <a:ext cx="131156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BC to XO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92329" y="72502"/>
            <a:ext cx="2923773" cy="1985167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ackgroundRemoval t="48000" b="94200" l="32103" r="69823"/>
                    </a14:imgEffect>
                  </a14:imgLayer>
                </a14:imgProps>
              </a:ext>
            </a:extLst>
          </a:blip>
          <a:srcRect l="27451" t="42253" r="25770"/>
          <a:stretch/>
        </p:blipFill>
        <p:spPr>
          <a:xfrm>
            <a:off x="9387945" y="162063"/>
            <a:ext cx="949007" cy="1380215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9358145" y="1360833"/>
            <a:ext cx="10086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xidative stres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8"/>
          <a:srcRect l="22823" t="18422" r="12121" b="19901"/>
          <a:stretch/>
        </p:blipFill>
        <p:spPr>
          <a:xfrm>
            <a:off x="2314688" y="2545839"/>
            <a:ext cx="1066535" cy="856153"/>
          </a:xfrm>
          <a:prstGeom prst="rect">
            <a:avLst/>
          </a:prstGeom>
        </p:spPr>
      </p:pic>
      <p:sp>
        <p:nvSpPr>
          <p:cNvPr id="25" name="Rectangle 24"/>
          <p:cNvSpPr/>
          <p:nvPr/>
        </p:nvSpPr>
        <p:spPr>
          <a:xfrm>
            <a:off x="2397352" y="3512798"/>
            <a:ext cx="90120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coa extract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ackgroundRemoval t="10000" b="90000" l="10000" r="9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315531" y="318767"/>
            <a:ext cx="2252596" cy="1126298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>
            <a:off x="2220143" y="1237723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silico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Straight Arrow Connector 36"/>
          <p:cNvCxnSpPr/>
          <p:nvPr/>
        </p:nvCxnSpPr>
        <p:spPr>
          <a:xfrm flipV="1">
            <a:off x="8355850" y="976188"/>
            <a:ext cx="1032095" cy="16521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&quot;No&quot; Symbol 38"/>
          <p:cNvSpPr/>
          <p:nvPr/>
        </p:nvSpPr>
        <p:spPr>
          <a:xfrm>
            <a:off x="8706953" y="500671"/>
            <a:ext cx="362139" cy="351499"/>
          </a:xfrm>
          <a:prstGeom prst="noSmoking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40" name="Chevron 39"/>
          <p:cNvSpPr/>
          <p:nvPr/>
        </p:nvSpPr>
        <p:spPr>
          <a:xfrm>
            <a:off x="3212206" y="713072"/>
            <a:ext cx="230978" cy="263116"/>
          </a:xfrm>
          <a:prstGeom prst="chevron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pic>
        <p:nvPicPr>
          <p:cNvPr id="41" name="Picture 4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171452" y="4059631"/>
            <a:ext cx="1502052" cy="841149"/>
          </a:xfrm>
          <a:prstGeom prst="rect">
            <a:avLst/>
          </a:prstGeom>
        </p:spPr>
      </p:pic>
      <p:sp>
        <p:nvSpPr>
          <p:cNvPr id="42" name="TextBox 41"/>
          <p:cNvSpPr txBox="1"/>
          <p:nvPr/>
        </p:nvSpPr>
        <p:spPr>
          <a:xfrm>
            <a:off x="2511166" y="5020943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 culture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17763" y="5455724"/>
            <a:ext cx="1307022" cy="979005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13"/>
          <a:srcRect l="5933" t="32075" r="30250" b="-972"/>
          <a:stretch/>
        </p:blipFill>
        <p:spPr>
          <a:xfrm>
            <a:off x="1829345" y="5496384"/>
            <a:ext cx="1197263" cy="809998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839466" y="5391923"/>
            <a:ext cx="1266161" cy="93566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030447" y="5443867"/>
            <a:ext cx="1599898" cy="862515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506637" y="6412802"/>
            <a:ext cx="110479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l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liferation </a:t>
            </a:r>
          </a:p>
        </p:txBody>
      </p:sp>
      <p:sp>
        <p:nvSpPr>
          <p:cNvPr id="6" name="Rectangle 5"/>
          <p:cNvSpPr/>
          <p:nvPr/>
        </p:nvSpPr>
        <p:spPr>
          <a:xfrm>
            <a:off x="1772823" y="6413567"/>
            <a:ext cx="113204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Colony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</a:rPr>
              <a:t>formation </a:t>
            </a:r>
            <a:endParaRPr lang="en-US" sz="1000" dirty="0"/>
          </a:p>
        </p:txBody>
      </p:sp>
      <p:sp>
        <p:nvSpPr>
          <p:cNvPr id="10" name="Rectangle 9"/>
          <p:cNvSpPr/>
          <p:nvPr/>
        </p:nvSpPr>
        <p:spPr>
          <a:xfrm>
            <a:off x="3327695" y="6352095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Wound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</a:rPr>
              <a:t>healing </a:t>
            </a:r>
            <a:endParaRPr lang="en-US" sz="1000" dirty="0"/>
          </a:p>
        </p:txBody>
      </p:sp>
      <p:sp>
        <p:nvSpPr>
          <p:cNvPr id="11" name="Rectangle 10"/>
          <p:cNvSpPr/>
          <p:nvPr/>
        </p:nvSpPr>
        <p:spPr>
          <a:xfrm>
            <a:off x="4832720" y="6321317"/>
            <a:ext cx="11192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err="1" smtClean="0">
                <a:latin typeface="Times New Roman" panose="02020603050405020304" pitchFamily="18" charset="0"/>
                <a:ea typeface="Calibri" panose="020F0502020204030204" pitchFamily="34" charset="0"/>
              </a:rPr>
              <a:t>Chemosensitivity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endParaRPr lang="en-US" dirty="0"/>
          </a:p>
        </p:txBody>
      </p:sp>
      <p:sp>
        <p:nvSpPr>
          <p:cNvPr id="13" name="Curved Down Arrow 12"/>
          <p:cNvSpPr/>
          <p:nvPr/>
        </p:nvSpPr>
        <p:spPr>
          <a:xfrm rot="18967462">
            <a:off x="191518" y="647022"/>
            <a:ext cx="1735028" cy="833314"/>
          </a:xfrm>
          <a:prstGeom prst="curvedDownArrow">
            <a:avLst>
              <a:gd name="adj1" fmla="val 25000"/>
              <a:gd name="adj2" fmla="val 50000"/>
              <a:gd name="adj3" fmla="val 20118"/>
            </a:avLst>
          </a:prstGeom>
          <a:solidFill>
            <a:schemeClr val="bg1"/>
          </a:solidFill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4" name="Notched Right Arrow 13"/>
          <p:cNvSpPr/>
          <p:nvPr/>
        </p:nvSpPr>
        <p:spPr>
          <a:xfrm>
            <a:off x="1145383" y="2731288"/>
            <a:ext cx="1062283" cy="348448"/>
          </a:xfrm>
          <a:prstGeom prst="notchedRightArrow">
            <a:avLst/>
          </a:prstGeom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Curved Right Arrow 14"/>
          <p:cNvSpPr/>
          <p:nvPr/>
        </p:nvSpPr>
        <p:spPr>
          <a:xfrm>
            <a:off x="1475715" y="3089420"/>
            <a:ext cx="695737" cy="1687468"/>
          </a:xfrm>
          <a:prstGeom prst="curvedRightArrow">
            <a:avLst>
              <a:gd name="adj1" fmla="val 25000"/>
              <a:gd name="adj2" fmla="val 50000"/>
              <a:gd name="adj3" fmla="val 37223"/>
            </a:avLst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33" name="Notched Right Arrow 32"/>
          <p:cNvSpPr/>
          <p:nvPr/>
        </p:nvSpPr>
        <p:spPr>
          <a:xfrm>
            <a:off x="3438766" y="2806449"/>
            <a:ext cx="755478" cy="348448"/>
          </a:xfrm>
          <a:prstGeom prst="notchedRightArrow">
            <a:avLst/>
          </a:prstGeom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7" name="Elbow Connector 16"/>
          <p:cNvCxnSpPr/>
          <p:nvPr/>
        </p:nvCxnSpPr>
        <p:spPr>
          <a:xfrm>
            <a:off x="4623749" y="2948644"/>
            <a:ext cx="1563434" cy="1531022"/>
          </a:xfrm>
          <a:prstGeom prst="bentConnector3">
            <a:avLst>
              <a:gd name="adj1" fmla="val 50000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" name="Picture 29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 flipV="1">
            <a:off x="4210401" y="2535563"/>
            <a:ext cx="434280" cy="808340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4002893" y="3305203"/>
            <a:ext cx="10550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 donor mice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Straight Arrow Connector 34"/>
          <p:cNvCxnSpPr/>
          <p:nvPr/>
        </p:nvCxnSpPr>
        <p:spPr>
          <a:xfrm>
            <a:off x="5396951" y="2946422"/>
            <a:ext cx="1203580" cy="22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8" name="Picture 57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078418" y="2259660"/>
            <a:ext cx="934010" cy="665015"/>
          </a:xfrm>
          <a:prstGeom prst="rect">
            <a:avLst/>
          </a:prstGeom>
        </p:spPr>
      </p:pic>
      <p:pic>
        <p:nvPicPr>
          <p:cNvPr id="59" name="Picture 58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8377047" y="2212851"/>
            <a:ext cx="1021950" cy="969049"/>
          </a:xfrm>
          <a:prstGeom prst="rect">
            <a:avLst/>
          </a:prstGeom>
        </p:spPr>
      </p:pic>
      <p:pic>
        <p:nvPicPr>
          <p:cNvPr id="61" name="Picture 60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6582569" y="2439406"/>
            <a:ext cx="1494054" cy="734086"/>
          </a:xfrm>
          <a:prstGeom prst="rect">
            <a:avLst/>
          </a:prstGeom>
        </p:spPr>
      </p:pic>
      <p:pic>
        <p:nvPicPr>
          <p:cNvPr id="62" name="Picture 61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6196281" y="3888214"/>
            <a:ext cx="1624541" cy="920979"/>
          </a:xfrm>
          <a:prstGeom prst="rect">
            <a:avLst/>
          </a:prstGeom>
        </p:spPr>
      </p:pic>
      <p:pic>
        <p:nvPicPr>
          <p:cNvPr id="63" name="Picture 62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7340422" y="2170504"/>
            <a:ext cx="769229" cy="769229"/>
          </a:xfrm>
          <a:prstGeom prst="rect">
            <a:avLst/>
          </a:prstGeom>
        </p:spPr>
      </p:pic>
      <p:pic>
        <p:nvPicPr>
          <p:cNvPr id="64" name="Picture 63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7074912" y="3759326"/>
            <a:ext cx="768163" cy="768163"/>
          </a:xfrm>
          <a:prstGeom prst="rect">
            <a:avLst/>
          </a:prstGeom>
        </p:spPr>
      </p:pic>
      <p:pic>
        <p:nvPicPr>
          <p:cNvPr id="65" name="Picture 64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6550400" y="5228424"/>
            <a:ext cx="1024217" cy="969348"/>
          </a:xfrm>
          <a:prstGeom prst="rect">
            <a:avLst/>
          </a:prstGeom>
        </p:spPr>
      </p:pic>
      <p:pic>
        <p:nvPicPr>
          <p:cNvPr id="66" name="Picture 65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10855058" y="2124951"/>
            <a:ext cx="1321458" cy="1144847"/>
          </a:xfrm>
          <a:prstGeom prst="rect">
            <a:avLst/>
          </a:prstGeom>
        </p:spPr>
      </p:pic>
      <p:cxnSp>
        <p:nvCxnSpPr>
          <p:cNvPr id="68" name="Straight Arrow Connector 67"/>
          <p:cNvCxnSpPr/>
          <p:nvPr/>
        </p:nvCxnSpPr>
        <p:spPr>
          <a:xfrm>
            <a:off x="9489440" y="2731288"/>
            <a:ext cx="11887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9" name="Picture 68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9608007" y="2013448"/>
            <a:ext cx="248966" cy="516427"/>
          </a:xfrm>
          <a:prstGeom prst="rect">
            <a:avLst/>
          </a:prstGeom>
        </p:spPr>
      </p:pic>
      <p:pic>
        <p:nvPicPr>
          <p:cNvPr id="70" name="Picture 69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9986581" y="2068148"/>
            <a:ext cx="484260" cy="387408"/>
          </a:xfrm>
          <a:prstGeom prst="rect">
            <a:avLst/>
          </a:prstGeom>
        </p:spPr>
      </p:pic>
      <p:sp>
        <p:nvSpPr>
          <p:cNvPr id="71" name="TextBox 70"/>
          <p:cNvSpPr txBox="1"/>
          <p:nvPr/>
        </p:nvSpPr>
        <p:spPr>
          <a:xfrm>
            <a:off x="9512043" y="2496594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X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0042465" y="2470311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E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9695610" y="2743066"/>
            <a:ext cx="8628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11251298" y="3058981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rvival</a:t>
            </a:r>
            <a:r>
              <a:rPr lang="en-US" b="1" dirty="0" smtClean="0"/>
              <a:t> </a:t>
            </a:r>
            <a:endParaRPr lang="en-US" dirty="0"/>
          </a:p>
        </p:txBody>
      </p:sp>
      <p:pic>
        <p:nvPicPr>
          <p:cNvPr id="76" name="Picture 75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6920963" y="5017926"/>
            <a:ext cx="2373662" cy="1587081"/>
          </a:xfrm>
          <a:prstGeom prst="rect">
            <a:avLst/>
          </a:prstGeom>
        </p:spPr>
      </p:pic>
      <p:pic>
        <p:nvPicPr>
          <p:cNvPr id="79" name="Picture 78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10273497" y="5097390"/>
            <a:ext cx="1371719" cy="1377815"/>
          </a:xfrm>
          <a:prstGeom prst="rect">
            <a:avLst/>
          </a:prstGeom>
        </p:spPr>
      </p:pic>
      <p:pic>
        <p:nvPicPr>
          <p:cNvPr id="80" name="Picture 79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10767077" y="5336417"/>
            <a:ext cx="381033" cy="438950"/>
          </a:xfrm>
          <a:prstGeom prst="rect">
            <a:avLst/>
          </a:prstGeom>
        </p:spPr>
      </p:pic>
      <p:sp>
        <p:nvSpPr>
          <p:cNvPr id="81" name="TextBox 80"/>
          <p:cNvSpPr txBox="1"/>
          <p:nvPr/>
        </p:nvSpPr>
        <p:spPr>
          <a:xfrm>
            <a:off x="6673969" y="6238819"/>
            <a:ext cx="8210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umor size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0366754" y="6221290"/>
            <a:ext cx="15297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umor weight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4" name="Straight Arrow Connector 83"/>
          <p:cNvCxnSpPr/>
          <p:nvPr/>
        </p:nvCxnSpPr>
        <p:spPr>
          <a:xfrm flipV="1">
            <a:off x="7557752" y="4410812"/>
            <a:ext cx="1330270" cy="42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5" name="Picture 84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7829239" y="3687032"/>
            <a:ext cx="865707" cy="518205"/>
          </a:xfrm>
          <a:prstGeom prst="rect">
            <a:avLst/>
          </a:prstGeom>
        </p:spPr>
      </p:pic>
      <p:sp>
        <p:nvSpPr>
          <p:cNvPr id="86" name="Rectangle 85"/>
          <p:cNvSpPr/>
          <p:nvPr/>
        </p:nvSpPr>
        <p:spPr>
          <a:xfrm>
            <a:off x="7761139" y="4137682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X</a:t>
            </a:r>
            <a:endParaRPr lang="en-US" sz="1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Rectangle 86"/>
          <p:cNvSpPr/>
          <p:nvPr/>
        </p:nvSpPr>
        <p:spPr>
          <a:xfrm>
            <a:off x="8302138" y="4086793"/>
            <a:ext cx="44114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E</a:t>
            </a:r>
            <a:endParaRPr lang="en-US" sz="1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9" name="Picture 88"/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9254770" y="3270844"/>
            <a:ext cx="749363" cy="1147805"/>
          </a:xfrm>
          <a:prstGeom prst="rect">
            <a:avLst/>
          </a:prstGeom>
        </p:spPr>
      </p:pic>
      <p:pic>
        <p:nvPicPr>
          <p:cNvPr id="90" name="Picture 89"/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10711455" y="3472019"/>
            <a:ext cx="1324864" cy="873932"/>
          </a:xfrm>
          <a:prstGeom prst="rect">
            <a:avLst/>
          </a:prstGeom>
        </p:spPr>
      </p:pic>
      <p:pic>
        <p:nvPicPr>
          <p:cNvPr id="91" name="Picture 90"/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9489359" y="4479666"/>
            <a:ext cx="1029994" cy="1108648"/>
          </a:xfrm>
          <a:prstGeom prst="rect">
            <a:avLst/>
          </a:prstGeom>
        </p:spPr>
      </p:pic>
      <p:pic>
        <p:nvPicPr>
          <p:cNvPr id="92" name="Picture 91"/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9311005" y="3857313"/>
            <a:ext cx="525695" cy="347924"/>
          </a:xfrm>
          <a:prstGeom prst="rect">
            <a:avLst/>
          </a:prstGeom>
        </p:spPr>
      </p:pic>
      <p:pic>
        <p:nvPicPr>
          <p:cNvPr id="93" name="Picture 92"/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10739086" y="3653664"/>
            <a:ext cx="549350" cy="363579"/>
          </a:xfrm>
          <a:prstGeom prst="rect">
            <a:avLst/>
          </a:prstGeom>
        </p:spPr>
      </p:pic>
      <p:pic>
        <p:nvPicPr>
          <p:cNvPr id="94" name="Picture 93"/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9710242" y="4899973"/>
            <a:ext cx="408146" cy="394078"/>
          </a:xfrm>
          <a:prstGeom prst="rect">
            <a:avLst/>
          </a:prstGeom>
        </p:spPr>
      </p:pic>
      <p:sp>
        <p:nvSpPr>
          <p:cNvPr id="95" name="Rectangle 94"/>
          <p:cNvSpPr/>
          <p:nvPr/>
        </p:nvSpPr>
        <p:spPr>
          <a:xfrm>
            <a:off x="7785701" y="4392617"/>
            <a:ext cx="76174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endParaRPr 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8938402" y="4320488"/>
            <a:ext cx="14606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rt Markers and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to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Rectangle 96"/>
          <p:cNvSpPr/>
          <p:nvPr/>
        </p:nvSpPr>
        <p:spPr>
          <a:xfrm>
            <a:off x="10614648" y="4345026"/>
            <a:ext cx="145264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er </a:t>
            </a:r>
            <a:r>
              <a:rPr lang="en-US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s and </a:t>
            </a:r>
            <a:r>
              <a:rPr lang="en-US" sz="10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isto</a:t>
            </a:r>
            <a:endParaRPr lang="en-US" sz="1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Rectangle 97"/>
          <p:cNvSpPr/>
          <p:nvPr/>
        </p:nvSpPr>
        <p:spPr>
          <a:xfrm>
            <a:off x="9109436" y="5368806"/>
            <a:ext cx="155202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dney </a:t>
            </a:r>
            <a:r>
              <a:rPr lang="en-US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s and </a:t>
            </a:r>
            <a:r>
              <a:rPr lang="en-US" sz="10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isto</a:t>
            </a:r>
            <a:endParaRPr lang="en-US" sz="1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0" name="Straight Arrow Connector 99"/>
          <p:cNvCxnSpPr/>
          <p:nvPr/>
        </p:nvCxnSpPr>
        <p:spPr>
          <a:xfrm>
            <a:off x="7923387" y="2806449"/>
            <a:ext cx="39271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Arrow Connector 101"/>
          <p:cNvCxnSpPr/>
          <p:nvPr/>
        </p:nvCxnSpPr>
        <p:spPr>
          <a:xfrm flipV="1">
            <a:off x="7361894" y="4661507"/>
            <a:ext cx="631039" cy="52604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Arrow Connector 108"/>
          <p:cNvCxnSpPr/>
          <p:nvPr/>
        </p:nvCxnSpPr>
        <p:spPr>
          <a:xfrm>
            <a:off x="6970940" y="4661507"/>
            <a:ext cx="16011" cy="53324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458172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9</TotalTime>
  <Words>48</Words>
  <Application>Microsoft Office PowerPoint</Application>
  <PresentationFormat>Widescreen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iyanks</dc:creator>
  <cp:lastModifiedBy>Priyanks</cp:lastModifiedBy>
  <cp:revision>20</cp:revision>
  <dcterms:created xsi:type="dcterms:W3CDTF">2022-12-13T09:17:46Z</dcterms:created>
  <dcterms:modified xsi:type="dcterms:W3CDTF">2022-12-15T10:12:04Z</dcterms:modified>
</cp:coreProperties>
</file>